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00675" cy="115236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4556B-7056-4E2D-B2FB-1FA341365F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0000" y="2689200"/>
            <a:ext cx="48607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0000" y="6660360"/>
            <a:ext cx="48607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C1D4F-F1F0-4358-87B8-E479278CA9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0000" y="268920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760480" y="268920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0000" y="666036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760480" y="666036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E2EE0-F18B-4CD0-80FD-4E19F8AC09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0000" y="2689200"/>
            <a:ext cx="15649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13400" y="2689200"/>
            <a:ext cx="15649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557160" y="2689200"/>
            <a:ext cx="15649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0000" y="6660360"/>
            <a:ext cx="15649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13400" y="6660360"/>
            <a:ext cx="15649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557160" y="6660360"/>
            <a:ext cx="15649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E0962-D4EC-443C-B3A4-50385F8855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0000" y="2689200"/>
            <a:ext cx="4860720" cy="76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0A8BE-0080-4BEC-AA6C-55223C5D78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0000" y="2689200"/>
            <a:ext cx="4860720" cy="76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2AD2A-6FF5-450C-8843-16F77F92FC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0000" y="2689200"/>
            <a:ext cx="2371680" cy="76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760480" y="2689200"/>
            <a:ext cx="2371680" cy="76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34B0E-4943-463A-9CA1-2DFA31EE30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D32B92-E45D-434C-B328-944942491C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0000" y="461880"/>
            <a:ext cx="4860720" cy="889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BBA10-2210-410F-A5A0-A93A189725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0000" y="268920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760480" y="2689200"/>
            <a:ext cx="2371680" cy="76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0000" y="666036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A6DB00-6A77-413D-9D57-341BAD0AF5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0000" y="2689200"/>
            <a:ext cx="2371680" cy="76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760480" y="268920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760480" y="666036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B2943-DC4D-4B80-A764-CD4B6DFFAF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0000" y="268920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760480" y="2689200"/>
            <a:ext cx="237168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0000" y="6660360"/>
            <a:ext cx="4860720" cy="362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A2375-EC2D-416F-897B-3B27ABA4B0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0000" y="461880"/>
            <a:ext cx="4860720" cy="19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0000" y="2689200"/>
            <a:ext cx="4860720" cy="76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69640" y="10491480"/>
            <a:ext cx="1260360" cy="80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844640" y="10491480"/>
            <a:ext cx="1711440" cy="80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870000" y="10491480"/>
            <a:ext cx="1260360" cy="80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98607F-0FF7-4BB9-B7B9-56E629F4D22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11240" y="5510160"/>
            <a:ext cx="4678200" cy="2590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08000" y="2881440"/>
            <a:ext cx="4678200" cy="2590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" descr=""/>
          <p:cNvPicPr/>
          <p:nvPr/>
        </p:nvPicPr>
        <p:blipFill>
          <a:blip r:embed="rId3"/>
          <a:srcRect l="1566" t="0" r="0" b="0"/>
          <a:stretch/>
        </p:blipFill>
        <p:spPr>
          <a:xfrm>
            <a:off x="108000" y="223920"/>
            <a:ext cx="4678200" cy="2590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"/>
          <p:cNvSpPr/>
          <p:nvPr/>
        </p:nvSpPr>
        <p:spPr>
          <a:xfrm>
            <a:off x="108000" y="2617920"/>
            <a:ext cx="3967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Ser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08000" y="5273640"/>
            <a:ext cx="3967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Ser 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08000" y="7902720"/>
            <a:ext cx="3967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Ser 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H="1" flipV="1">
            <a:off x="3369960" y="6654600"/>
            <a:ext cx="50760" cy="4381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097080" y="707544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241800" y="64720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V="1">
            <a:off x="3889440" y="7189560"/>
            <a:ext cx="111240" cy="190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922560" y="713088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673440" y="73263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523960" y="6278400"/>
            <a:ext cx="206640" cy="223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197080" y="61578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cc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631960" y="62737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3122640" y="6541920"/>
            <a:ext cx="0" cy="2145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917800" y="671508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Tbp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002040" y="63482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H="1" flipV="1">
            <a:off x="2897280" y="6938640"/>
            <a:ext cx="46080" cy="82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813040" y="698508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fu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724120" y="68882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3558960" y="5754600"/>
            <a:ext cx="4680" cy="117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421080" y="55800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Ir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427560" y="58672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3639960" y="6300720"/>
            <a:ext cx="176400" cy="2746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565440" y="612144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P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463920" y="64627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178160" y="60660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P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H="1" flipV="1">
            <a:off x="3741840" y="7173720"/>
            <a:ext cx="147600" cy="206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571920" y="71215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564000" y="5761080"/>
            <a:ext cx="109440" cy="1206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548160" y="58644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213000" y="5788080"/>
            <a:ext cx="158760" cy="171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260880" y="59421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700360" y="5634000"/>
            <a:ext cx="755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APP7_13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816360" y="6300720"/>
            <a:ext cx="92160" cy="250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3421080" y="6681960"/>
            <a:ext cx="579600" cy="4111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713040" y="646920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873600" y="66722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816360" y="6300720"/>
            <a:ext cx="244440" cy="2588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976560" y="656604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260360" y="590544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411200" y="56055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317600" y="55976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235160" y="55944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058760" y="56134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155600" y="55958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H="1" flipV="1">
            <a:off x="1243080" y="5773320"/>
            <a:ext cx="233280" cy="1666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4105440" y="5857560"/>
            <a:ext cx="215640" cy="111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762360" y="574848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Tbp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249800" y="57006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V="1">
            <a:off x="2475000" y="7165440"/>
            <a:ext cx="171360" cy="250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160720" y="73278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Yfe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511360" y="70120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612720" y="6070320"/>
            <a:ext cx="108000" cy="158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87520" y="57960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36600" y="61977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Rps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V="1">
            <a:off x="3421080" y="6689880"/>
            <a:ext cx="324000" cy="4032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552840" y="66088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816360" y="6300720"/>
            <a:ext cx="339840" cy="252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4030560" y="64022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H="1">
            <a:off x="4254480" y="6227640"/>
            <a:ext cx="138240" cy="181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129200" y="62532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787480" y="5994360"/>
            <a:ext cx="135000" cy="1494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593800" y="581508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U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803680" y="61545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544840" y="5711760"/>
            <a:ext cx="14040" cy="109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347920" y="55483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D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541520" y="56530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592360" y="6611760"/>
            <a:ext cx="104760" cy="144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305080" y="64627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fu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593800" y="659916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flipV="1">
            <a:off x="949320" y="7056000"/>
            <a:ext cx="166680" cy="181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063800" y="70023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12720" y="71658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Mgl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flipV="1">
            <a:off x="1855800" y="7279920"/>
            <a:ext cx="4680" cy="2458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643040" y="74739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Fkp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730520" y="70866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H="1" flipV="1">
            <a:off x="1275840" y="6140160"/>
            <a:ext cx="24120" cy="98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103400" y="61833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Pck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074600" y="606276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H="1">
            <a:off x="4249440" y="6229440"/>
            <a:ext cx="142920" cy="612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124160" y="687852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612720" y="6751800"/>
            <a:ext cx="90720" cy="1965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79440" y="68943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Ta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585720" y="65818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432160" y="58374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8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1260360" y="536400"/>
            <a:ext cx="138240" cy="2988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295280" y="5205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081080" y="80028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1260360" y="539280"/>
            <a:ext cx="55800" cy="2955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190520" y="3556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H="1" flipV="1">
            <a:off x="1223640" y="525600"/>
            <a:ext cx="36360" cy="3096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087560" y="3459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H="1" flipV="1">
            <a:off x="1430280" y="360360"/>
            <a:ext cx="333360" cy="2952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303200" y="17928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211400" y="1792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H="1" flipV="1">
            <a:off x="1335240" y="353880"/>
            <a:ext cx="428400" cy="3016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585800" y="6015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781440" y="1890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Hgb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990960" y="368280"/>
            <a:ext cx="0" cy="135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3870360" y="5238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4286160" y="15145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flipH="1">
            <a:off x="4381200" y="1665360"/>
            <a:ext cx="119160" cy="1206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230720" y="18018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flipH="1" flipV="1">
            <a:off x="1260360" y="345960"/>
            <a:ext cx="503280" cy="309600"/>
          </a:xfrm>
          <a:prstGeom prst="line">
            <a:avLst/>
          </a:prstGeom>
          <a:ln cap="rnd" w="9360">
            <a:solidFill>
              <a:srgbClr val="ffffff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116000" y="1778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H="1" flipV="1">
            <a:off x="4392720" y="1375920"/>
            <a:ext cx="108000" cy="181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286160" y="11970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565440" y="15573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P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3852720" y="1449000"/>
            <a:ext cx="144720" cy="142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H="1" flipV="1">
            <a:off x="4335120" y="1371600"/>
            <a:ext cx="165240" cy="185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208400" y="11970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197080" y="11779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U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2381400" y="950760"/>
            <a:ext cx="134640" cy="252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389320" y="7682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895560" y="124308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3328920" y="536400"/>
            <a:ext cx="0" cy="135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998800" y="351000"/>
            <a:ext cx="684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APP7_13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218040" y="6811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2998800" y="368280"/>
            <a:ext cx="1440" cy="2286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805120" y="200160"/>
            <a:ext cx="468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TorZ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874960" y="6033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170080" y="404640"/>
            <a:ext cx="98280" cy="1731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flipH="1">
            <a:off x="2111400" y="398520"/>
            <a:ext cx="47520" cy="1825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1981080" y="227160"/>
            <a:ext cx="468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D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125800" y="5983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987560" y="5922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H="1" flipV="1">
            <a:off x="4284720" y="1375920"/>
            <a:ext cx="216000" cy="181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4122720" y="11970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V="1">
            <a:off x="3852720" y="1413000"/>
            <a:ext cx="281160" cy="1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997440" y="12430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0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V="1">
            <a:off x="3852720" y="1426680"/>
            <a:ext cx="24120" cy="1652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3745080" y="12430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flipH="1" flipV="1">
            <a:off x="3610080" y="1420920"/>
            <a:ext cx="242640" cy="171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478320" y="12542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V="1">
            <a:off x="4105440" y="1628280"/>
            <a:ext cx="50760" cy="287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3824280" y="18921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P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033800" y="14508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H="1" flipV="1">
            <a:off x="4054320" y="1633320"/>
            <a:ext cx="51120" cy="2826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924360" y="14558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H="1" flipV="1">
            <a:off x="3276720" y="1736640"/>
            <a:ext cx="149040" cy="216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3327480" y="19191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Sur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3132000" y="155592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008160" y="1403280"/>
            <a:ext cx="1800" cy="2286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881440" y="16556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835360" y="12333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Cys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H="1" flipV="1">
            <a:off x="2643120" y="1558440"/>
            <a:ext cx="52560" cy="2206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505240" y="13795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585880" y="1751040"/>
            <a:ext cx="720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fuA, Yfe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flipV="1">
            <a:off x="4213080" y="2241360"/>
            <a:ext cx="250920" cy="107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4394160" y="20923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3600360" y="2293920"/>
            <a:ext cx="684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APP7_13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V="1">
            <a:off x="4140360" y="597960"/>
            <a:ext cx="215640" cy="2019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4272120" y="5317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3817800" y="7272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Tbp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 flipH="1" flipV="1">
            <a:off x="2367000" y="950760"/>
            <a:ext cx="14400" cy="252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241720" y="7650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085840" y="78120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 flipH="1" flipV="1">
            <a:off x="2214360" y="955800"/>
            <a:ext cx="166680" cy="2476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 flipV="1">
            <a:off x="2389320" y="4105080"/>
            <a:ext cx="239760" cy="215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197080" y="42847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Gap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521080" y="39020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 flipV="1">
            <a:off x="1949400" y="3998880"/>
            <a:ext cx="82440" cy="169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1641600" y="4159080"/>
            <a:ext cx="7714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APP7_194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1916280" y="38149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flipH="1" flipV="1">
            <a:off x="2306160" y="3587760"/>
            <a:ext cx="141480" cy="1922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254320" y="374328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U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2165400" y="34052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2233440" y="390060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H="1" flipV="1">
            <a:off x="2376360" y="4164120"/>
            <a:ext cx="14400" cy="1569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flipH="1" flipV="1">
            <a:off x="1863360" y="4006800"/>
            <a:ext cx="81000" cy="169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1728720" y="38178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 flipV="1">
            <a:off x="3529080" y="4024440"/>
            <a:ext cx="191880" cy="296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3276720" y="42847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 flipV="1">
            <a:off x="1547640" y="3094200"/>
            <a:ext cx="231840" cy="2188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 flipV="1">
            <a:off x="1547640" y="3095640"/>
            <a:ext cx="144720" cy="217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 flipV="1">
            <a:off x="1547640" y="3098520"/>
            <a:ext cx="81000" cy="2142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 flipV="1">
            <a:off x="1547640" y="3095640"/>
            <a:ext cx="1800" cy="217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1666800" y="28954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1573200" y="28926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1494000" y="28926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405080" y="28940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1332000" y="32781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II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3606840" y="37879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 flipV="1">
            <a:off x="739800" y="3798720"/>
            <a:ext cx="52200" cy="370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576360" y="41227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Pg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685800" y="36021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flipH="1" flipV="1">
            <a:off x="3381480" y="4038120"/>
            <a:ext cx="147600" cy="2826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3251160" y="38289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flipV="1">
            <a:off x="3708360" y="4020840"/>
            <a:ext cx="176400" cy="5158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3492360" y="45007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P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3772080" y="38098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 flipV="1">
            <a:off x="3529080" y="3995640"/>
            <a:ext cx="468360" cy="325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898800" y="37861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 flipH="1" flipV="1">
            <a:off x="2754000" y="3241800"/>
            <a:ext cx="198360" cy="1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2881440" y="33498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TorZ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593800" y="305604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 flipV="1">
            <a:off x="2448000" y="3581280"/>
            <a:ext cx="123840" cy="198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2465280" y="33973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flipV="1">
            <a:off x="792000" y="4543200"/>
            <a:ext cx="289080" cy="215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1019160" y="43736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96720" y="4734000"/>
            <a:ext cx="771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APP7_149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flipV="1">
            <a:off x="1878120" y="4711320"/>
            <a:ext cx="1440" cy="252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1751040" y="45194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1693800" y="49323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Fkp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2197080" y="45021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 flipV="1">
            <a:off x="2173320" y="4679640"/>
            <a:ext cx="190440" cy="4460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1873080" y="50767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Gpm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flipH="1">
            <a:off x="1812960" y="3033720"/>
            <a:ext cx="216000" cy="144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1676520" y="32036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1944720" y="288144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Pfl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2305080" y="33926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 flipH="1" flipV="1">
            <a:off x="2437920" y="3606480"/>
            <a:ext cx="19080" cy="1746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 flipH="1">
            <a:off x="2782800" y="5987880"/>
            <a:ext cx="6480" cy="158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655720" y="614844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6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 flipH="1" flipV="1">
            <a:off x="1309320" y="5778360"/>
            <a:ext cx="166680" cy="162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 flipH="1" flipV="1">
            <a:off x="1369800" y="5799240"/>
            <a:ext cx="106200" cy="1411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 flipH="1" flipV="1">
            <a:off x="1433160" y="5808600"/>
            <a:ext cx="42840" cy="131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 flipV="1">
            <a:off x="1476360" y="5803560"/>
            <a:ext cx="28440" cy="136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 flipV="1">
            <a:off x="1486080" y="5789520"/>
            <a:ext cx="107640" cy="144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 flipH="1">
            <a:off x="1117440" y="6697800"/>
            <a:ext cx="84240" cy="1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914400" y="68054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1044720" y="6532560"/>
            <a:ext cx="502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Ts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 flipV="1">
            <a:off x="3917880" y="3160440"/>
            <a:ext cx="0" cy="215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787920" y="29718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718080" y="3348000"/>
            <a:ext cx="502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Hgb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4753080" y="-28440"/>
            <a:ext cx="503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MW [kDa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4824360" y="54756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4879800" y="41760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4829040" y="93024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4884840" y="8002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4842000" y="140508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4897440" y="12747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4842000" y="204624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4897440" y="19162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4824360" y="309708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4879800" y="296712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4829040" y="347976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4884840" y="334980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4842000" y="395460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4897440" y="38242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4842000" y="459576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4897440" y="446580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4824360" y="572436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4879800" y="559440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4829040" y="610704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4884840" y="59770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4842000" y="658188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4897440" y="64515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4842000" y="722304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4897440" y="70930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389480" y="223920"/>
            <a:ext cx="3967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2 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4389480" y="2882880"/>
            <a:ext cx="3967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2 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4392720" y="5511960"/>
            <a:ext cx="3967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2 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146160" y="28702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 flipH="1" flipV="1">
            <a:off x="183960" y="2979360"/>
            <a:ext cx="120600" cy="158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204840" y="30891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V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71360" y="1951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 flipH="1" flipV="1">
            <a:off x="209160" y="309240"/>
            <a:ext cx="120600" cy="158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216000" y="43956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V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193680" y="54799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 flipH="1" flipV="1">
            <a:off x="242640" y="5587560"/>
            <a:ext cx="120600" cy="158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181080" y="57006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V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 flipH="1" flipV="1">
            <a:off x="2665440" y="4248000"/>
            <a:ext cx="287280" cy="144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2881440" y="432108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Znu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514600" y="42069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4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 flipH="1" flipV="1">
            <a:off x="1204920" y="3852720"/>
            <a:ext cx="92160" cy="2527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 flipV="1">
            <a:off x="1297080" y="3865680"/>
            <a:ext cx="12600" cy="239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1117440" y="406872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Tuf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1068480" y="36180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1192320" y="36003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5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 flipH="1" flipV="1">
            <a:off x="2725200" y="7265520"/>
            <a:ext cx="119160" cy="2955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 flipV="1">
            <a:off x="2844720" y="7272000"/>
            <a:ext cx="144720" cy="289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2557440" y="7542360"/>
            <a:ext cx="755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APP7_075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2952720" y="71913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2674800" y="716292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7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706320" y="5921280"/>
            <a:ext cx="216000" cy="108000"/>
          </a:xfrm>
          <a:prstGeom prst="ellipse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936720" y="5616720"/>
            <a:ext cx="71280" cy="144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933480" y="5796000"/>
            <a:ext cx="216000" cy="108000"/>
          </a:xfrm>
          <a:prstGeom prst="ellipse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1044720" y="58546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612720" y="5472000"/>
            <a:ext cx="503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Fus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3" name="" descr=""/>
          <p:cNvPicPr/>
          <p:nvPr/>
        </p:nvPicPr>
        <p:blipFill>
          <a:blip r:embed="rId4"/>
          <a:stretch/>
        </p:blipFill>
        <p:spPr>
          <a:xfrm>
            <a:off x="108000" y="8156520"/>
            <a:ext cx="4678200" cy="2590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24" name=""/>
          <p:cNvSpPr/>
          <p:nvPr/>
        </p:nvSpPr>
        <p:spPr>
          <a:xfrm>
            <a:off x="108000" y="10550520"/>
            <a:ext cx="3967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Ser 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1297080" y="851076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1044720" y="861840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 flipH="1">
            <a:off x="2731680" y="8358120"/>
            <a:ext cx="615960" cy="1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3132000" y="8178840"/>
            <a:ext cx="470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I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 flipH="1">
            <a:off x="2882880" y="8358120"/>
            <a:ext cx="465120" cy="185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 flipH="1">
            <a:off x="3103200" y="8372520"/>
            <a:ext cx="244440" cy="181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 flipH="1">
            <a:off x="3063600" y="8358120"/>
            <a:ext cx="284040" cy="1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3348000" y="8358120"/>
            <a:ext cx="216000" cy="395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3348000" y="8358120"/>
            <a:ext cx="684360" cy="4111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3348000" y="8358120"/>
            <a:ext cx="792360" cy="4111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 flipH="1" flipV="1">
            <a:off x="1433160" y="8675280"/>
            <a:ext cx="144360" cy="144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 flipH="1" flipV="1">
            <a:off x="1289160" y="8675280"/>
            <a:ext cx="288720" cy="144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1506600" y="8729640"/>
            <a:ext cx="468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Pck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3492360" y="8636040"/>
            <a:ext cx="28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3852720" y="8772480"/>
            <a:ext cx="3240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4068720" y="8663040"/>
            <a:ext cx="360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052800" y="8499600"/>
            <a:ext cx="331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2878200" y="852156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2698920" y="8532720"/>
            <a:ext cx="361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2521080" y="8420040"/>
            <a:ext cx="3459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 flipV="1">
            <a:off x="684360" y="8768880"/>
            <a:ext cx="99720" cy="304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 flipH="1" flipV="1">
            <a:off x="666360" y="8769240"/>
            <a:ext cx="17640" cy="324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433440" y="8715240"/>
            <a:ext cx="3585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649440" y="86104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 flipH="1" flipV="1">
            <a:off x="4192200" y="8318160"/>
            <a:ext cx="57240" cy="144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4068720" y="8426520"/>
            <a:ext cx="433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Hgb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4140360" y="821052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1979640" y="8228160"/>
            <a:ext cx="288720" cy="109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1692360" y="8102520"/>
            <a:ext cx="468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D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2195640" y="8228160"/>
            <a:ext cx="360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 flipH="1" flipV="1">
            <a:off x="2879280" y="8764200"/>
            <a:ext cx="58680" cy="181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2771640" y="8929800"/>
            <a:ext cx="468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Ush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2808360" y="8655120"/>
            <a:ext cx="360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 flipH="1" flipV="1">
            <a:off x="4257360" y="8921880"/>
            <a:ext cx="181080" cy="108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4390920" y="8948880"/>
            <a:ext cx="505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P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4245120" y="884880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 flipH="1" flipV="1">
            <a:off x="3111120" y="9380520"/>
            <a:ext cx="73080" cy="216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3060720" y="9309240"/>
            <a:ext cx="395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0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3095640" y="9542520"/>
            <a:ext cx="433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fu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1979640" y="8228160"/>
            <a:ext cx="0" cy="109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1730520" y="8228160"/>
            <a:ext cx="3585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 flipH="1" flipV="1">
            <a:off x="2123640" y="9777240"/>
            <a:ext cx="73080" cy="216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2087640" y="9974160"/>
            <a:ext cx="433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Yfe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2087640" y="9717120"/>
            <a:ext cx="360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 flipV="1">
            <a:off x="1709640" y="9896040"/>
            <a:ext cx="0" cy="1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1512720" y="10047240"/>
            <a:ext cx="433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Fkp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1476360" y="9848880"/>
            <a:ext cx="3240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 flipH="1" flipV="1">
            <a:off x="2749680" y="8768880"/>
            <a:ext cx="203040" cy="196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2484360" y="8715240"/>
            <a:ext cx="360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 flipH="1" flipV="1">
            <a:off x="4134960" y="8337600"/>
            <a:ext cx="112680" cy="125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3889440" y="826452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 flipV="1">
            <a:off x="4392720" y="9218520"/>
            <a:ext cx="0" cy="216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4140360" y="9380520"/>
            <a:ext cx="541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4338720" y="9056520"/>
            <a:ext cx="342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 flipH="1" flipV="1">
            <a:off x="4327560" y="9218520"/>
            <a:ext cx="71280" cy="216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4176720" y="9002880"/>
            <a:ext cx="3016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 flipH="1" flipV="1">
            <a:off x="1150560" y="8966160"/>
            <a:ext cx="73080" cy="216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 flipH="1" flipV="1">
            <a:off x="1044720" y="8966160"/>
            <a:ext cx="179280" cy="217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1044720" y="9147240"/>
            <a:ext cx="43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Tuf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1116000" y="8924760"/>
            <a:ext cx="3240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828720" y="8948880"/>
            <a:ext cx="349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 flipH="1" flipV="1">
            <a:off x="4536720" y="9291240"/>
            <a:ext cx="36360" cy="358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4319640" y="9650520"/>
            <a:ext cx="541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Omp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4500720" y="923760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1981080" y="8231040"/>
            <a:ext cx="142920" cy="1238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1981080" y="8348760"/>
            <a:ext cx="360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 flipV="1">
            <a:off x="4537080" y="8624880"/>
            <a:ext cx="34920" cy="125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4362480" y="8696160"/>
            <a:ext cx="433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Frp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4537080" y="8408880"/>
            <a:ext cx="3240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 flipH="1" flipV="1">
            <a:off x="1728360" y="9740520"/>
            <a:ext cx="466920" cy="252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1692360" y="9644040"/>
            <a:ext cx="3603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 flipV="1">
            <a:off x="684360" y="8786880"/>
            <a:ext cx="179280" cy="287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828720" y="870912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504720" y="9056520"/>
            <a:ext cx="433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Pg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 flipH="1" flipV="1">
            <a:off x="4253040" y="9204120"/>
            <a:ext cx="139680" cy="2300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4032360" y="9124920"/>
            <a:ext cx="33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3348000" y="8354880"/>
            <a:ext cx="469800" cy="397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3602160" y="8732880"/>
            <a:ext cx="3585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4824360" y="846288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4879800" y="833292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4829040" y="884556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4884840" y="871524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4842000" y="932004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4897440" y="91900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4842000" y="9961560"/>
            <a:ext cx="108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4897440" y="983124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250920" y="10863360"/>
            <a:ext cx="4500360" cy="0"/>
          </a:xfrm>
          <a:prstGeom prst="line">
            <a:avLst/>
          </a:prstGeom>
          <a:ln w="3492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216000" y="1084572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≈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4282920" y="1084572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≈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2165400" y="1083960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 flipV="1">
            <a:off x="1224000" y="8275320"/>
            <a:ext cx="225360" cy="1969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 flipV="1">
            <a:off x="1224000" y="8291520"/>
            <a:ext cx="133200" cy="1713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 flipV="1">
            <a:off x="1224000" y="8303760"/>
            <a:ext cx="50760" cy="1587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 flipH="1" flipV="1">
            <a:off x="1206000" y="8302680"/>
            <a:ext cx="17640" cy="163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 flipH="1" flipV="1">
            <a:off x="1125360" y="8300520"/>
            <a:ext cx="98640" cy="1652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1008000" y="8420040"/>
            <a:ext cx="469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ffffff"/>
                </a:solidFill>
                <a:latin typeface="Arial"/>
              </a:rPr>
              <a:t>ApxII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998640" y="812484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1101600" y="8102520"/>
            <a:ext cx="373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1216080" y="8101080"/>
            <a:ext cx="3315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1311120" y="8134200"/>
            <a:ext cx="344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 flipH="1" flipV="1">
            <a:off x="1047600" y="8284680"/>
            <a:ext cx="176400" cy="1810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 flipH="1" flipV="1">
            <a:off x="976320" y="8281800"/>
            <a:ext cx="247680" cy="18396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 flipH="1" flipV="1">
            <a:off x="902880" y="8286840"/>
            <a:ext cx="320760" cy="1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 flipH="1" flipV="1">
            <a:off x="826560" y="8286840"/>
            <a:ext cx="397080" cy="1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898560" y="8115480"/>
            <a:ext cx="336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2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792000" y="8109000"/>
            <a:ext cx="316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684360" y="811548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576360" y="8115480"/>
            <a:ext cx="309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468360" y="8153280"/>
            <a:ext cx="323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3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 flipH="1" flipV="1">
            <a:off x="714240" y="8304120"/>
            <a:ext cx="509760" cy="1620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1368360" y="8247240"/>
            <a:ext cx="344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ffffff"/>
                </a:solidFill>
                <a:latin typeface="Arial"/>
              </a:rPr>
              <a:t>11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4392720" y="8156520"/>
            <a:ext cx="3967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2 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7T10:36:31Z</dcterms:created>
  <dc:creator>buettner</dc:creator>
  <dc:description/>
  <dc:language>en-US</dc:language>
  <cp:lastModifiedBy>buettner</cp:lastModifiedBy>
  <dcterms:modified xsi:type="dcterms:W3CDTF">2011-04-07T10:41:50Z</dcterms:modified>
  <cp:revision>2</cp:revision>
  <dc:subject/>
  <dc:title>Folie 1</dc:title>
</cp:coreProperties>
</file>